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28" userDrawn="1">
          <p15:clr>
            <a:srgbClr val="A4A3A4"/>
          </p15:clr>
        </p15:guide>
        <p15:guide id="2" pos="6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75" autoAdjust="0"/>
    <p:restoredTop sz="76994" autoAdjust="0"/>
  </p:normalViewPr>
  <p:slideViewPr>
    <p:cSldViewPr snapToGrid="0" showGuides="1">
      <p:cViewPr varScale="1">
        <p:scale>
          <a:sx n="84" d="100"/>
          <a:sy n="84" d="100"/>
        </p:scale>
        <p:origin x="1548" y="84"/>
      </p:cViewPr>
      <p:guideLst>
        <p:guide orient="horz" pos="3528"/>
        <p:guide pos="6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5517E5-4F1C-4D20-A02D-AEDCF01FED0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2F07453-0ECF-46A6-BC99-D4548DFE490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4EDD94-F144-4E7C-9C13-CFA078069A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09D0C8-123E-4496-A690-1468B9FAB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7910FB-3F88-4A71-9BAD-1F1BCCDAD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9763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2D8EC8-072B-4C99-B2D6-B561429D87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F881A20-1386-408E-ACD1-D76C2A37DA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381713-2031-413C-A727-70A2C9CE15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D94A7-A6E9-4DE4-B9B3-E90593614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1E968F-8FF0-4B88-A3EA-49EECB7F10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0303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7635A36-E2AD-4FDC-AF35-5074BC88938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46DB17-E1AF-4C87-A318-71FA0A1028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DCBAE7-17F0-4380-BF20-AE9519CF81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D9EA19-D0E1-4996-829B-A6E225F8FC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18E561-C41A-4AEB-860F-32A15163EB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98920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BD1D1-C839-4215-8DC3-F232853CF0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FF1F26-E367-412E-817A-CBCEF27B090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E98845-B9E0-4DCD-908A-D70B1D1988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72EC73-6043-4AA5-8851-9955BCA070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615E03-686D-4D17-AF4F-D6D670B7EE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495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520DB6-BBB0-4D58-B793-A4CDD2712B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E474AF-A02B-4D87-BF75-FA129A7DDDD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81A5131-36FF-4FD7-A518-2A358C468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A175C0-F1A8-438C-A4CC-D3FF926919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5449EA9-FFC9-4436-80D1-761EC1D200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5045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9D045A-3D3D-44C5-A6BA-77F44FD0FF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382F3D-8740-4BD5-9814-BCC3DB3F92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AB5561-2819-4F35-87A6-727E73F282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1433BF-C0B6-44CB-B757-EF670A540D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1F5346-96AE-41CF-B7DC-DB1F99A04F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BED66A-1C7B-4D0B-93CB-83BC9E4000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131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6957E1-E46F-4DCF-A16B-27843D0B10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63FAFE-03CB-47E6-834B-DC68439B37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236584A-D9E5-4AAF-A196-112196ACFDA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0E2A30-EC35-4FD3-A072-F25ECB4A9C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78C036C-DFA8-4CC5-9BDA-5DA9F741704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5959273-388B-4AD2-A1A4-5792CF276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4864EA-B883-43E5-BE5F-D5A02C0158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4BFBB00-80D0-4E50-8602-53A30FF0AA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5493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ABF569-0BE7-4567-A6DB-BF4CA25033A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BF26865-86AD-499A-B4FA-8E40CE2067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EB739F8-7023-47E4-A330-4C70949278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3C215DE-4569-4DA5-A922-9B47D1A826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94032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83B3262-9D0C-4A8E-ACD2-CA0F7525EA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81C7003-EC1D-4870-959E-3E875E766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488306-14A0-401C-ADA0-06EE54B4CA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6406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90434E-5B9E-4C4E-A7E5-9297865742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0F786-A7F6-4E09-9A37-A3C0355CEB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945C6A-5F01-4AAB-9825-C77D15F3DE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99DCB0-734C-4504-8768-640119AEB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DD2D312-3133-4D15-B50F-0F827EA69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F4CD3E7-D227-4F95-A653-E9BCFCFE05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4914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268A6-4CD4-4C7C-87F6-512F926790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C596D59-7C09-4141-A700-99D552B9A40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3C5A7A-51B4-4E20-89AD-294AF845220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1E306-88E4-4A26-AB04-8F485747F3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F6B142F-3488-412D-8333-29783654A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C1FB80C-CEAB-4E11-BA9A-8F23D91558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03668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5992521-6580-4893-92BB-54596A9F8E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CEA449-A8F2-4288-BFB1-B7B5B17944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C98FC3-1D3F-4ABE-92CC-17B6DC1488E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76DCA6-0C85-462D-A021-3D124C17757F}" type="datetimeFigureOut">
              <a:rPr lang="en-US" smtClean="0"/>
              <a:t>8/25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1EE594B-381E-4C71-928E-C62CAC4504D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0BEEC0-A708-411E-BF66-A14203591E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52E224-5F2B-4FAF-8327-F92DE5EFE3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764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636F1E1D-0A2C-4866-8EED-8ABA1CB52C7C}"/>
              </a:ext>
            </a:extLst>
          </p:cNvPr>
          <p:cNvGrpSpPr/>
          <p:nvPr/>
        </p:nvGrpSpPr>
        <p:grpSpPr>
          <a:xfrm>
            <a:off x="1055794" y="-14807"/>
            <a:ext cx="10211439" cy="5960795"/>
            <a:chOff x="1055794" y="60609"/>
            <a:chExt cx="10211439" cy="5960795"/>
          </a:xfrm>
        </p:grpSpPr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863546D7-E960-479C-9646-8786B3490C69}"/>
                </a:ext>
              </a:extLst>
            </p:cNvPr>
            <p:cNvGrpSpPr/>
            <p:nvPr/>
          </p:nvGrpSpPr>
          <p:grpSpPr>
            <a:xfrm>
              <a:off x="1055794" y="60609"/>
              <a:ext cx="10211439" cy="5960795"/>
              <a:chOff x="1055794" y="-6066"/>
              <a:chExt cx="10211439" cy="5960795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0E96CA91-3BD8-4E33-A054-56978598030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42439" y="581209"/>
                <a:ext cx="3099418" cy="2378070"/>
              </a:xfrm>
              <a:prstGeom prst="rect">
                <a:avLst/>
              </a:prstGeom>
            </p:spPr>
          </p:pic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154B48EF-7921-433A-A68F-89C7B3AEA4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05127" y="581209"/>
                <a:ext cx="3099418" cy="2385084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6ECD0FD9-7118-4695-83AA-C954EA855E7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8167815" y="577664"/>
                <a:ext cx="3099418" cy="2353335"/>
              </a:xfrm>
              <a:prstGeom prst="rect">
                <a:avLst/>
              </a:prstGeom>
            </p:spPr>
          </p:pic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C36528B4-50C4-4927-8C8E-E3ED7ADF121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797863" y="3550756"/>
                <a:ext cx="3099418" cy="2393021"/>
              </a:xfrm>
              <a:prstGeom prst="rect">
                <a:avLst/>
              </a:prstGeom>
            </p:spPr>
          </p:pic>
          <p:sp>
            <p:nvSpPr>
              <p:cNvPr id="20" name="Content Placeholder 7">
                <a:extLst>
                  <a:ext uri="{FF2B5EF4-FFF2-40B4-BE49-F238E27FC236}">
                    <a16:creationId xmlns:a16="http://schemas.microsoft.com/office/drawing/2014/main" id="{61E43373-6C7C-4FBF-9EA7-00408EF645F1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3663457" y="3227159"/>
                <a:ext cx="1973772" cy="345537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rm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Font typeface="Arial" panose="020B0604020202020204" pitchFamily="34" charset="0"/>
                  <a:buNone/>
                </a:pP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REMBRANDT database</a:t>
                </a:r>
              </a:p>
            </p:txBody>
          </p:sp>
          <p:pic>
            <p:nvPicPr>
              <p:cNvPr id="28" name="Picture 27">
                <a:extLst>
                  <a:ext uri="{FF2B5EF4-FFF2-40B4-BE49-F238E27FC236}">
                    <a16:creationId xmlns:a16="http://schemas.microsoft.com/office/drawing/2014/main" id="{EAC912B2-4F54-48EA-9BEC-74A71AF2F98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6365391" y="3561709"/>
                <a:ext cx="3099418" cy="2393020"/>
              </a:xfrm>
              <a:prstGeom prst="rect">
                <a:avLst/>
              </a:prstGeom>
            </p:spPr>
          </p:pic>
          <p:sp>
            <p:nvSpPr>
              <p:cNvPr id="29" name="Content Placeholder 7">
                <a:extLst>
                  <a:ext uri="{FF2B5EF4-FFF2-40B4-BE49-F238E27FC236}">
                    <a16:creationId xmlns:a16="http://schemas.microsoft.com/office/drawing/2014/main" id="{3D39303A-F9B0-45BB-B9A3-0433901F5ADC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7139025" y="3250773"/>
                <a:ext cx="1973772" cy="345537"/>
              </a:xfrm>
              <a:prstGeom prst="rect">
                <a:avLst/>
              </a:prstGeom>
            </p:spPr>
            <p:txBody>
              <a:bodyPr vert="horz" lIns="91440" tIns="45720" rIns="91440" bIns="45720" rtlCol="0" anchor="ctr">
                <a:normAutofit/>
              </a:bodyPr>
              <a:lstStyle>
                <a:lvl1pPr marL="228600" indent="-228600" algn="l" defTabSz="914400" rtl="0" eaLnBrk="1" latinLnBrk="0" hangingPunct="1"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685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1143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600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20574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5146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9718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4290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886200" indent="-228600" algn="l" defTabSz="914400" rtl="0" eaLnBrk="1" latinLnBrk="0" hangingPunct="1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indent="0">
                  <a:buFont typeface="Arial" panose="020B0604020202020204" pitchFamily="34" charset="0"/>
                  <a:buNone/>
                </a:pPr>
                <a:r>
                  <a:rPr lang="en-US" sz="12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ravendeel</a:t>
                </a:r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database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E1194BFB-92B9-47C3-B1FE-B34E87E58AF5}"/>
                  </a:ext>
                </a:extLst>
              </p:cNvPr>
              <p:cNvSpPr txBox="1"/>
              <p:nvPr/>
            </p:nvSpPr>
            <p:spPr>
              <a:xfrm>
                <a:off x="1948309" y="147825"/>
                <a:ext cx="1687677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CGA database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atform: HG-U133A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5EC82737-C8CD-4571-AF15-53BBC2F24404}"/>
                  </a:ext>
                </a:extLst>
              </p:cNvPr>
              <p:cNvSpPr txBox="1"/>
              <p:nvPr/>
            </p:nvSpPr>
            <p:spPr>
              <a:xfrm>
                <a:off x="5415218" y="147824"/>
                <a:ext cx="201017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CGA database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atform: Agilent-4502A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0A2EB00-FBFE-4E6E-9951-59D00651B375}"/>
                  </a:ext>
                </a:extLst>
              </p:cNvPr>
              <p:cNvSpPr txBox="1"/>
              <p:nvPr/>
            </p:nvSpPr>
            <p:spPr>
              <a:xfrm>
                <a:off x="8877906" y="147823"/>
                <a:ext cx="2010178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CGA database</a:t>
                </a:r>
              </a:p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latform: RNA-seq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4169A12E-F295-4F56-BAD4-60A93E9167C0}"/>
                  </a:ext>
                </a:extLst>
              </p:cNvPr>
              <p:cNvSpPr txBox="1"/>
              <p:nvPr/>
            </p:nvSpPr>
            <p:spPr>
              <a:xfrm>
                <a:off x="1055794" y="0"/>
                <a:ext cx="3732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24DC1D33-8DDD-4543-8BF6-0D8652F08998}"/>
                  </a:ext>
                </a:extLst>
              </p:cNvPr>
              <p:cNvSpPr txBox="1"/>
              <p:nvPr/>
            </p:nvSpPr>
            <p:spPr>
              <a:xfrm>
                <a:off x="4615605" y="-6066"/>
                <a:ext cx="3732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3A4CF47C-0885-4262-9F42-8133AB3544AF}"/>
                  </a:ext>
                </a:extLst>
              </p:cNvPr>
              <p:cNvSpPr txBox="1"/>
              <p:nvPr/>
            </p:nvSpPr>
            <p:spPr>
              <a:xfrm>
                <a:off x="8009452" y="0"/>
                <a:ext cx="3732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1C11F479-E78C-43D8-BF32-15565B50E834}"/>
                  </a:ext>
                </a:extLst>
              </p:cNvPr>
              <p:cNvSpPr txBox="1"/>
              <p:nvPr/>
            </p:nvSpPr>
            <p:spPr>
              <a:xfrm>
                <a:off x="2539271" y="3153355"/>
                <a:ext cx="3732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36B64B82-D52A-4921-A123-CA50EBC8DB87}"/>
                  </a:ext>
                </a:extLst>
              </p:cNvPr>
              <p:cNvSpPr txBox="1"/>
              <p:nvPr/>
            </p:nvSpPr>
            <p:spPr>
              <a:xfrm>
                <a:off x="6254836" y="3115764"/>
                <a:ext cx="37328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</a:p>
            </p:txBody>
          </p:sp>
        </p:grp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56441615-69E6-4919-B1F1-0FEF99633729}"/>
                </a:ext>
              </a:extLst>
            </p:cNvPr>
            <p:cNvSpPr txBox="1"/>
            <p:nvPr/>
          </p:nvSpPr>
          <p:spPr>
            <a:xfrm>
              <a:off x="2395193" y="703376"/>
              <a:ext cx="75571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F1A961E-26D6-419F-BD7F-A178BD353162}"/>
                </a:ext>
              </a:extLst>
            </p:cNvPr>
            <p:cNvSpPr txBox="1"/>
            <p:nvPr/>
          </p:nvSpPr>
          <p:spPr>
            <a:xfrm>
              <a:off x="5881837" y="712803"/>
              <a:ext cx="75571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5B9D7E93-41CA-4F3F-BEB2-0D8AC016FA42}"/>
                </a:ext>
              </a:extLst>
            </p:cNvPr>
            <p:cNvSpPr txBox="1"/>
            <p:nvPr/>
          </p:nvSpPr>
          <p:spPr>
            <a:xfrm>
              <a:off x="9339667" y="704080"/>
              <a:ext cx="75571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F85731B-21EB-4F85-AD89-8E5FCEB7ECAD}"/>
                </a:ext>
              </a:extLst>
            </p:cNvPr>
            <p:cNvSpPr txBox="1"/>
            <p:nvPr/>
          </p:nvSpPr>
          <p:spPr>
            <a:xfrm>
              <a:off x="3980546" y="3694263"/>
              <a:ext cx="75571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FE460A6E-0A0B-44E3-8591-5F09F208C1E1}"/>
                </a:ext>
              </a:extLst>
            </p:cNvPr>
            <p:cNvSpPr txBox="1"/>
            <p:nvPr/>
          </p:nvSpPr>
          <p:spPr>
            <a:xfrm>
              <a:off x="7565524" y="3694263"/>
              <a:ext cx="755714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p&lt;0.001</a:t>
              </a:r>
            </a:p>
          </p:txBody>
        </p:sp>
      </p:grpSp>
      <p:sp>
        <p:nvSpPr>
          <p:cNvPr id="26" name="TextBox 25">
            <a:extLst>
              <a:ext uri="{FF2B5EF4-FFF2-40B4-BE49-F238E27FC236}">
                <a16:creationId xmlns:a16="http://schemas.microsoft.com/office/drawing/2014/main" id="{F9198E2E-0281-4F50-918F-3E454D6C4E9F}"/>
              </a:ext>
            </a:extLst>
          </p:cNvPr>
          <p:cNvSpPr txBox="1"/>
          <p:nvPr/>
        </p:nvSpPr>
        <p:spPr>
          <a:xfrm>
            <a:off x="106458" y="6059998"/>
            <a:ext cx="11931572" cy="769441"/>
          </a:xfrm>
          <a:prstGeom prst="rect">
            <a:avLst/>
          </a:prstGeom>
          <a:noFill/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1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Figure 1: TSPO gene expression analysis in different GBM cohort datasets.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Patient GBM samples from the TCGA-GBM database, using the three different platforms (A) Affymetrix HG-U133A platform, (B) Agilent-4502A platform, (C) RNA-seq platform, (D) the Rembrandt database, and (E) the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ravendeel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batase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, were analyzed using </a:t>
            </a:r>
            <a:r>
              <a:rPr lang="en-US" sz="1100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lioVis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mRNA TSPO expression levels in GBM samples were compared to tumor-free brain samples using each database. Patient numbers and p-value of the pairwise comparisons using t-test (with Bonferroni correction) are included in </a:t>
            </a:r>
            <a:r>
              <a:rPr lang="en-US" sz="110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ch graph.</a:t>
            </a:r>
            <a:endParaRPr lang="en-US" sz="11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656981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9</TotalTime>
  <Words>143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rlet Maria Acanda De La Rocha</dc:creator>
  <cp:lastModifiedBy>Arlet Maria Acanda De La Rocha</cp:lastModifiedBy>
  <cp:revision>9</cp:revision>
  <dcterms:created xsi:type="dcterms:W3CDTF">2021-04-29T18:39:35Z</dcterms:created>
  <dcterms:modified xsi:type="dcterms:W3CDTF">2021-08-25T17:54:28Z</dcterms:modified>
</cp:coreProperties>
</file>